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81" r:id="rId3"/>
    <p:sldId id="278" r:id="rId4"/>
    <p:sldId id="280" r:id="rId5"/>
    <p:sldId id="286" r:id="rId6"/>
    <p:sldId id="287" r:id="rId7"/>
    <p:sldId id="276" r:id="rId8"/>
    <p:sldId id="289" r:id="rId9"/>
    <p:sldId id="288" r:id="rId10"/>
    <p:sldId id="284" r:id="rId11"/>
    <p:sldId id="27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4377BD-2CF8-4B24-A0E9-0E954BC054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21F94A-DD8E-483B-B987-F4A375AF70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8D50F7-98FF-41F0-92AC-59D7ECE49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02C39-685E-47E9-BCD8-E22891B14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49F57-1098-4859-9D67-C3DE4BF68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568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3FE60-A59B-4179-8996-9E6F90EF5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226416-80F8-476B-85D9-F95F1840EE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54B75-DE39-4889-AB1A-0C18FDAB7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B8B837-3F37-4B11-A15A-86D67353B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2702E8-25F4-4B7B-92C9-E3245A924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770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AC7C07-FC5D-4FBE-8895-B212BF45D0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F7FD98-386E-40B4-9455-D1487E4307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C13129-7EC1-4739-8D14-BB06891FA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EC50E1-F6CB-4FB9-8A99-D9417B32F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316DC-31AA-40A1-9C1C-DD44C05A2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77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87F3C-53F3-4F25-85A6-B0802BBA2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1D0D46-E15A-45E8-9BED-CF5E68ABE7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831313-C085-4B33-B40F-75487A9DF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5D00D-DB6B-4935-B732-614F3D629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D18E7-C0F0-4B9F-BD9E-66CDF6F2F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257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84597-C048-4916-A8D3-EC3295F94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997698-A8D6-43CA-A676-EA51FB03CF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1819B7-E9CB-4D85-8373-36A562320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06600C-51E1-4224-850A-D419092D3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3161E-4CB7-4E12-952C-6A6801F1B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46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3C26E-106F-4F56-82DD-4A45E2AF0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3294AB-C781-418C-BD7D-35964D2FC3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FF49F9-7A1D-4685-9F62-F50DAC1979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DB3E2B-7F96-4E23-AC53-C779A0CB7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F16C88-66B6-4D0C-91F4-6DEA26477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7807EE-C0F1-45FD-BC23-98DF138CF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402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9A5BF-A807-458C-9892-B082A545D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8B7D08-2AA2-443F-A12F-BB5B1AD832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386814-1F2A-4B81-8D5D-E5DB453AAC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485E96A-BFC0-42A9-B054-D1B8EFF684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74A6A1-612C-49AD-8A2D-77F7F3063E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E331F4-AEF6-419A-9FB4-4D3BBCC7E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267C7C-F2EE-4C69-9C89-DB4FB1BF8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31D229-464F-4CD6-80D2-9911A6F2F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410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D98CB4-8851-45FE-A0BE-6405B756F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D2A314-1C00-4139-9F1D-7F443D818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6D9FDF-B099-4D05-B6A4-D9C13ADE0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98D25D-F3A8-48F8-A38F-F7D4984EF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45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335AD1-CD4F-448E-A5F8-29976D3F8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846A34-A8D7-4A0F-85A7-196BBB663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6E65F1-EA56-4618-9AA6-244A31AE6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356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8EF93-805F-4AC4-8380-4C8187BAE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D1F8D2-65E0-4C7B-8C40-4B0830A715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73C1B4-DA3C-4C82-A9D5-CF107CD9C1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C7E4C5-1AA4-442D-9C9C-E0C1FE200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716208-8A9C-4E2E-B6F3-831A98B1E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FAA47C-3AA2-4BE7-957E-91B88CC38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42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570F3-FE52-4DE5-9A5E-8EEBB1D92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A6D89F-DAF8-4F37-B5BD-197B1B368D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45107A-8936-4795-8A42-4A48AFF58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7E7EB0-D05D-48D1-A899-8D80CC6AE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ED5E0-CBC3-47D5-9171-8BAB4B80E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B17210-750D-415B-BFD4-1745263DC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0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62E37B-D11B-43DD-AAA2-A7ECCFA90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5B8158-C50B-4D8E-B209-E6A034808A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AFFEFF-8199-43F3-90A2-5A31354735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1A3D6-3628-45AE-AC51-2DC7D894C337}" type="datetimeFigureOut">
              <a:rPr lang="en-US" smtClean="0"/>
              <a:t>8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3E4EB7-28DB-4C3B-9B7E-AAFDCCF90F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574D1-9142-4322-84A1-A7D85839D6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A3360-734D-42BE-B1C0-6991A25A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646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078A326-CB92-49C6-9B0E-847AD1BE0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7869" y="2103437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FIGURE 1	</a:t>
            </a:r>
          </a:p>
        </p:txBody>
      </p:sp>
    </p:spTree>
    <p:extLst>
      <p:ext uri="{BB962C8B-B14F-4D97-AF65-F5344CB8AC3E}">
        <p14:creationId xmlns:p14="http://schemas.microsoft.com/office/powerpoint/2010/main" val="8614041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0102F87-298A-4383-B823-35B0858FB8B0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BMI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5E3141-A308-4345-988E-86312ED08EC1}"/>
              </a:ext>
            </a:extLst>
          </p:cNvPr>
          <p:cNvSpPr txBox="1"/>
          <p:nvPr/>
        </p:nvSpPr>
        <p:spPr>
          <a:xfrm>
            <a:off x="222091" y="4629671"/>
            <a:ext cx="1111213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03-27-2020  mice</a:t>
            </a:r>
          </a:p>
          <a:p>
            <a:r>
              <a:rPr lang="en-US" dirty="0"/>
              <a:t>BMI1: B Moloney Leukemia Virus Type 1  </a:t>
            </a:r>
          </a:p>
          <a:p>
            <a:r>
              <a:rPr lang="en-US" dirty="0"/>
              <a:t>Protein: 10ug WCL  12% gel, Transfer ON 30mV, </a:t>
            </a:r>
          </a:p>
          <a:p>
            <a:r>
              <a:rPr lang="en-US" dirty="0"/>
              <a:t>1st Antibody: BMI1 (D42B3) anti Rabbit (ON 1:1000), CST 5856S, 41-43 </a:t>
            </a:r>
            <a:r>
              <a:rPr lang="en-US" dirty="0" err="1"/>
              <a:t>kDa</a:t>
            </a:r>
            <a:r>
              <a:rPr lang="en-US" dirty="0"/>
              <a:t>; 2nd Antibody: GAR (1:5000)  </a:t>
            </a:r>
          </a:p>
          <a:p>
            <a:r>
              <a:rPr lang="en-US" dirty="0"/>
              <a:t>Developed 60sec ECL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583CE28E-DEDC-B547-AD82-D984B43FA079}"/>
              </a:ext>
            </a:extLst>
          </p:cNvPr>
          <p:cNvGrpSpPr/>
          <p:nvPr/>
        </p:nvGrpSpPr>
        <p:grpSpPr>
          <a:xfrm>
            <a:off x="2653477" y="474003"/>
            <a:ext cx="8049470" cy="3831554"/>
            <a:chOff x="3256792" y="497582"/>
            <a:chExt cx="8049470" cy="383155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AB4E44C-659A-89C8-5409-8455ACE6F304}"/>
                </a:ext>
              </a:extLst>
            </p:cNvPr>
            <p:cNvGrpSpPr/>
            <p:nvPr/>
          </p:nvGrpSpPr>
          <p:grpSpPr>
            <a:xfrm>
              <a:off x="3256792" y="497582"/>
              <a:ext cx="5678416" cy="3831554"/>
              <a:chOff x="3470985" y="1369253"/>
              <a:chExt cx="5678416" cy="3831554"/>
            </a:xfrm>
          </p:grpSpPr>
          <p:pic>
            <p:nvPicPr>
              <p:cNvPr id="3" name="Picture 2" descr="A close-up of a test&#10;&#10;AI-generated content may be incorrect.">
                <a:extLst>
                  <a:ext uri="{FF2B5EF4-FFF2-40B4-BE49-F238E27FC236}">
                    <a16:creationId xmlns:a16="http://schemas.microsoft.com/office/drawing/2014/main" id="{78407038-AB2A-A0B0-14F8-734E517498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99946" y="1369253"/>
                <a:ext cx="5549455" cy="3831554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B7A36CF-A2F4-4E6B-915C-0F12CA80B7C6}"/>
                  </a:ext>
                </a:extLst>
              </p:cNvPr>
              <p:cNvSpPr txBox="1"/>
              <p:nvPr/>
            </p:nvSpPr>
            <p:spPr>
              <a:xfrm>
                <a:off x="3470985" y="1541556"/>
                <a:ext cx="685800" cy="29905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ts val="200"/>
                  </a:spcBef>
                </a:pPr>
                <a:r>
                  <a:rPr lang="en-US" sz="1000" dirty="0"/>
                  <a:t>25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0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75</a:t>
                </a:r>
              </a:p>
              <a:p>
                <a:pPr>
                  <a:lnSpc>
                    <a:spcPct val="200000"/>
                  </a:lnSpc>
                  <a:spcBef>
                    <a:spcPts val="200"/>
                  </a:spcBef>
                </a:pPr>
                <a:r>
                  <a:rPr lang="en-US" sz="1000" dirty="0"/>
                  <a:t>5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37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25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2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0</a:t>
                </a:r>
              </a:p>
            </p:txBody>
          </p: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967691C4-1307-4D25-9C7D-8C64D979B224}"/>
                  </a:ext>
                </a:extLst>
              </p:cNvPr>
              <p:cNvGrpSpPr/>
              <p:nvPr/>
            </p:nvGrpSpPr>
            <p:grpSpPr>
              <a:xfrm>
                <a:off x="4156785" y="3122407"/>
                <a:ext cx="4778827" cy="880332"/>
                <a:chOff x="4362051" y="2390560"/>
                <a:chExt cx="4778827" cy="880332"/>
              </a:xfrm>
            </p:grpSpPr>
            <p:grpSp>
              <p:nvGrpSpPr>
                <p:cNvPr id="34" name="Group 33">
                  <a:extLst>
                    <a:ext uri="{FF2B5EF4-FFF2-40B4-BE49-F238E27FC236}">
                      <a16:creationId xmlns:a16="http://schemas.microsoft.com/office/drawing/2014/main" id="{9910D42B-3863-4493-9F96-0D905E1E9007}"/>
                    </a:ext>
                  </a:extLst>
                </p:cNvPr>
                <p:cNvGrpSpPr/>
                <p:nvPr/>
              </p:nvGrpSpPr>
              <p:grpSpPr>
                <a:xfrm>
                  <a:off x="4362051" y="2390560"/>
                  <a:ext cx="3930914" cy="0"/>
                  <a:chOff x="5189365" y="4522981"/>
                  <a:chExt cx="3930914" cy="0"/>
                </a:xfrm>
              </p:grpSpPr>
              <p:cxnSp>
                <p:nvCxnSpPr>
                  <p:cNvPr id="30" name="Straight Connector 29">
                    <a:extLst>
                      <a:ext uri="{FF2B5EF4-FFF2-40B4-BE49-F238E27FC236}">
                        <a16:creationId xmlns:a16="http://schemas.microsoft.com/office/drawing/2014/main" id="{BE1EBF72-AFD8-4799-B588-C433CF266F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89365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33241A83-67B0-4360-BA05-56A2ED0D86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64752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Straight Connector 31">
                    <a:extLst>
                      <a:ext uri="{FF2B5EF4-FFF2-40B4-BE49-F238E27FC236}">
                        <a16:creationId xmlns:a16="http://schemas.microsoft.com/office/drawing/2014/main" id="{D59A5AD7-6176-4BC9-AAEE-EDB7DADE6F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238469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Straight Connector 32">
                    <a:extLst>
                      <a:ext uri="{FF2B5EF4-FFF2-40B4-BE49-F238E27FC236}">
                        <a16:creationId xmlns:a16="http://schemas.microsoft.com/office/drawing/2014/main" id="{41B543B0-6DC3-4EDC-AF4D-7F353D63CD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260098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59826EC0-8093-4518-8FE2-163BF3B70353}"/>
                    </a:ext>
                  </a:extLst>
                </p:cNvPr>
                <p:cNvSpPr txBox="1"/>
                <p:nvPr/>
              </p:nvSpPr>
              <p:spPr>
                <a:xfrm>
                  <a:off x="4421968" y="2470673"/>
                  <a:ext cx="4718910" cy="8002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-NO      BMI1-KO          WT-HO      BMI1-KO</a:t>
                  </a:r>
                </a:p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NO 		        HO</a:t>
                  </a:r>
                </a:p>
                <a:p>
                  <a:endParaRPr lang="en-US" dirty="0"/>
                </a:p>
              </p:txBody>
            </p:sp>
          </p:grpSp>
        </p:grp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CA94B70F-976F-BC96-7356-63DF8826F9B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629188" y="1802716"/>
              <a:ext cx="1603387" cy="164606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AE959A0-A81F-847E-967E-ECC9628F47C2}"/>
                </a:ext>
              </a:extLst>
            </p:cNvPr>
            <p:cNvSpPr txBox="1"/>
            <p:nvPr/>
          </p:nvSpPr>
          <p:spPr>
            <a:xfrm>
              <a:off x="10434591" y="1713123"/>
              <a:ext cx="87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MI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20908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EC888FB-0B99-46ED-A5B5-614DDDAF5BA6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B-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9D48FB-4899-4F7F-853B-83BA8A782530}"/>
              </a:ext>
            </a:extLst>
          </p:cNvPr>
          <p:cNvSpPr txBox="1"/>
          <p:nvPr/>
        </p:nvSpPr>
        <p:spPr>
          <a:xfrm>
            <a:off x="622457" y="4995561"/>
            <a:ext cx="1087824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04-24-19  B-actin 10ug   </a:t>
            </a:r>
          </a:p>
          <a:p>
            <a:r>
              <a:rPr lang="en-US" dirty="0"/>
              <a:t>12% gel, Transfer ON 30mV, Antibody: B-actin conjugated HRP anti Rabbit (ON 1:5000) 42KDa, CST #4970 </a:t>
            </a:r>
          </a:p>
          <a:p>
            <a:r>
              <a:rPr lang="en-US" dirty="0"/>
              <a:t>Developed:  10sec ECL, KQ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, PC: positive control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2459C9B-250F-B36D-F94C-F9B08E014515}"/>
              </a:ext>
            </a:extLst>
          </p:cNvPr>
          <p:cNvGrpSpPr/>
          <p:nvPr/>
        </p:nvGrpSpPr>
        <p:grpSpPr>
          <a:xfrm>
            <a:off x="2996360" y="612460"/>
            <a:ext cx="7938204" cy="3398669"/>
            <a:chOff x="2996360" y="612460"/>
            <a:chExt cx="7938204" cy="3398669"/>
          </a:xfrm>
        </p:grpSpPr>
        <p:pic>
          <p:nvPicPr>
            <p:cNvPr id="21" name="Picture 20" descr="A close-up of a test&#10;&#10;AI-generated content may be incorrect.">
              <a:extLst>
                <a:ext uri="{FF2B5EF4-FFF2-40B4-BE49-F238E27FC236}">
                  <a16:creationId xmlns:a16="http://schemas.microsoft.com/office/drawing/2014/main" id="{A3618252-83FE-30D4-31BE-F2C41CFBDC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2434" y="612460"/>
              <a:ext cx="5648913" cy="3398669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8B7DDC8-60CE-B081-5F1C-FD0B1A691283}"/>
                </a:ext>
              </a:extLst>
            </p:cNvPr>
            <p:cNvGrpSpPr/>
            <p:nvPr/>
          </p:nvGrpSpPr>
          <p:grpSpPr>
            <a:xfrm>
              <a:off x="3469929" y="2741905"/>
              <a:ext cx="4949182" cy="880332"/>
              <a:chOff x="4362051" y="2390560"/>
              <a:chExt cx="4778827" cy="880332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6A2081EF-A200-590F-4F9A-924ECED050BE}"/>
                  </a:ext>
                </a:extLst>
              </p:cNvPr>
              <p:cNvGrpSpPr/>
              <p:nvPr/>
            </p:nvGrpSpPr>
            <p:grpSpPr>
              <a:xfrm>
                <a:off x="4362051" y="2390560"/>
                <a:ext cx="3930914" cy="0"/>
                <a:chOff x="5189365" y="4522981"/>
                <a:chExt cx="3930914" cy="0"/>
              </a:xfrm>
            </p:grpSpPr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620318C7-C26B-9CB8-40FF-33D00638C3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89365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CF25C341-BA12-0088-F382-1F69F3924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64752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76786C98-A120-C4A5-B067-4AA6FB0F08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38469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2A90C179-E377-C2A4-A054-EE697D3FDF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260098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1A5D39F-AE2F-3C21-2F0B-F8328B87498D}"/>
                  </a:ext>
                </a:extLst>
              </p:cNvPr>
              <p:cNvSpPr txBox="1"/>
              <p:nvPr/>
            </p:nvSpPr>
            <p:spPr>
              <a:xfrm>
                <a:off x="4421968" y="2470673"/>
                <a:ext cx="4718910" cy="8002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-NO      BMI1-KO          WT-HO      BMI1-KO            PC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	NO 		        HO</a:t>
                </a:r>
              </a:p>
              <a:p>
                <a:endParaRPr lang="en-US" dirty="0"/>
              </a:p>
            </p:txBody>
          </p:sp>
        </p:grp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6CF73806-1410-C7CF-1447-26BDE2C6B1E3}"/>
                </a:ext>
              </a:extLst>
            </p:cNvPr>
            <p:cNvCxnSpPr/>
            <p:nvPr/>
          </p:nvCxnSpPr>
          <p:spPr>
            <a:xfrm>
              <a:off x="7802311" y="2741905"/>
              <a:ext cx="3845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D96A37B-09F0-37E7-8A02-CCB3337271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459506" y="2236350"/>
              <a:ext cx="1603387" cy="164606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130B4AE-1DCC-AA62-94B9-AF0420789CA6}"/>
                </a:ext>
              </a:extLst>
            </p:cNvPr>
            <p:cNvSpPr txBox="1"/>
            <p:nvPr/>
          </p:nvSpPr>
          <p:spPr>
            <a:xfrm>
              <a:off x="10062893" y="2127128"/>
              <a:ext cx="87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/>
                <a:t>-acti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FB1B564-58DB-2807-7413-4D8F723BC076}"/>
                </a:ext>
              </a:extLst>
            </p:cNvPr>
            <p:cNvSpPr txBox="1"/>
            <p:nvPr/>
          </p:nvSpPr>
          <p:spPr>
            <a:xfrm>
              <a:off x="2996360" y="816513"/>
              <a:ext cx="685800" cy="3144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200"/>
                </a:spcBef>
                <a:spcAft>
                  <a:spcPts val="200"/>
                </a:spcAft>
              </a:pPr>
              <a:r>
                <a:rPr lang="en-US" sz="1000" dirty="0"/>
                <a:t>250</a:t>
              </a:r>
            </a:p>
            <a:p>
              <a:pPr>
                <a:spcBef>
                  <a:spcPts val="200"/>
                </a:spcBef>
                <a:spcAft>
                  <a:spcPts val="200"/>
                </a:spcAft>
              </a:pPr>
              <a:r>
                <a:rPr lang="en-US" sz="1000" dirty="0"/>
                <a:t>150</a:t>
              </a:r>
            </a:p>
            <a:p>
              <a:pPr>
                <a:spcBef>
                  <a:spcPts val="200"/>
                </a:spcBef>
                <a:spcAft>
                  <a:spcPts val="200"/>
                </a:spcAft>
              </a:pPr>
              <a:r>
                <a:rPr lang="en-US" sz="1000" dirty="0"/>
                <a:t>100</a:t>
              </a:r>
            </a:p>
            <a:p>
              <a:pPr>
                <a:spcBef>
                  <a:spcPts val="200"/>
                </a:spcBef>
                <a:spcAft>
                  <a:spcPts val="200"/>
                </a:spcAft>
              </a:pPr>
              <a:endParaRPr lang="en-US" sz="1000" dirty="0"/>
            </a:p>
            <a:p>
              <a:pPr>
                <a:spcBef>
                  <a:spcPts val="600"/>
                </a:spcBef>
                <a:spcAft>
                  <a:spcPts val="200"/>
                </a:spcAft>
              </a:pPr>
              <a:r>
                <a:rPr lang="en-US" sz="1000" dirty="0"/>
                <a:t>75</a:t>
              </a:r>
            </a:p>
            <a:p>
              <a:pPr>
                <a:lnSpc>
                  <a:spcPct val="200000"/>
                </a:lnSpc>
                <a:spcBef>
                  <a:spcPts val="600"/>
                </a:spcBef>
              </a:pPr>
              <a:r>
                <a:rPr lang="en-US" sz="1000" dirty="0"/>
                <a:t>50</a:t>
              </a:r>
            </a:p>
            <a:p>
              <a:pPr>
                <a:spcBef>
                  <a:spcPts val="600"/>
                </a:spcBef>
              </a:pPr>
              <a:endParaRPr lang="en-US" sz="1000" dirty="0"/>
            </a:p>
            <a:p>
              <a:pPr>
                <a:spcBef>
                  <a:spcPts val="600"/>
                </a:spcBef>
              </a:pPr>
              <a:r>
                <a:rPr lang="en-US" sz="1000" dirty="0"/>
                <a:t>37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25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20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59255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0237235-C6CD-445B-8D42-9F6595A66120}"/>
              </a:ext>
            </a:extLst>
          </p:cNvPr>
          <p:cNvSpPr txBox="1"/>
          <p:nvPr/>
        </p:nvSpPr>
        <p:spPr>
          <a:xfrm>
            <a:off x="571182" y="207942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DRP1 Mi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4A5DBF-87FE-4E2B-814B-CC4FF4C0F089}"/>
              </a:ext>
            </a:extLst>
          </p:cNvPr>
          <p:cNvSpPr txBox="1"/>
          <p:nvPr/>
        </p:nvSpPr>
        <p:spPr>
          <a:xfrm>
            <a:off x="753361" y="4671197"/>
            <a:ext cx="978401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10-21-2019; </a:t>
            </a:r>
          </a:p>
          <a:p>
            <a:r>
              <a:rPr lang="en-US" dirty="0"/>
              <a:t>10ug total protein, 12% gel, Transfer ON 30mV, </a:t>
            </a:r>
          </a:p>
          <a:p>
            <a:r>
              <a:rPr lang="en-US" dirty="0"/>
              <a:t>1st Antibody: DRP1 anti Rabbit (ON 1:1000) 78-82kDa, CST #8570; 2nd Antibody: GAR (1:5000)   </a:t>
            </a:r>
          </a:p>
          <a:p>
            <a:r>
              <a:rPr lang="en-US" dirty="0"/>
              <a:t>Developed: KQ 45sec ECL</a:t>
            </a:r>
          </a:p>
          <a:p>
            <a:r>
              <a:rPr lang="en-US" dirty="0"/>
              <a:t>NO: normoxia; HO: hyperoxia, WT: wild type; KO: Knockout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9BF29A1A-2D34-CE9D-DD76-F60AB1FFFCE1}"/>
              </a:ext>
            </a:extLst>
          </p:cNvPr>
          <p:cNvGrpSpPr/>
          <p:nvPr/>
        </p:nvGrpSpPr>
        <p:grpSpPr>
          <a:xfrm>
            <a:off x="2944895" y="1068178"/>
            <a:ext cx="6558585" cy="2930491"/>
            <a:chOff x="3047444" y="1042541"/>
            <a:chExt cx="6558585" cy="2930491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75B0979B-D166-3647-3D90-194E265B2FDF}"/>
                </a:ext>
              </a:extLst>
            </p:cNvPr>
            <p:cNvGrpSpPr/>
            <p:nvPr/>
          </p:nvGrpSpPr>
          <p:grpSpPr>
            <a:xfrm>
              <a:off x="3047444" y="1042541"/>
              <a:ext cx="6558585" cy="2930491"/>
              <a:chOff x="3363083" y="1060429"/>
              <a:chExt cx="6558585" cy="2930491"/>
            </a:xfrm>
          </p:grpSpPr>
          <p:pic>
            <p:nvPicPr>
              <p:cNvPr id="14" name="Picture 13" descr="A paper with black lines&#10;&#10;AI-generated content may be incorrect.">
                <a:extLst>
                  <a:ext uri="{FF2B5EF4-FFF2-40B4-BE49-F238E27FC236}">
                    <a16:creationId xmlns:a16="http://schemas.microsoft.com/office/drawing/2014/main" id="{EEF24516-2DFA-20D3-1B0E-F1A7C9FB7B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63083" y="1060429"/>
                <a:ext cx="4770081" cy="2930491"/>
              </a:xfrm>
              <a:prstGeom prst="rect">
                <a:avLst/>
              </a:prstGeom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BA1BCBBC-A30B-4B21-9F1F-87C04F658E74}"/>
                  </a:ext>
                </a:extLst>
              </p:cNvPr>
              <p:cNvGrpSpPr/>
              <p:nvPr/>
            </p:nvGrpSpPr>
            <p:grpSpPr>
              <a:xfrm>
                <a:off x="3467126" y="1292737"/>
                <a:ext cx="6454542" cy="2092881"/>
                <a:chOff x="3487891" y="1378668"/>
                <a:chExt cx="7025551" cy="2092881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E694E211-1763-42C0-A8E2-BE6434A7A365}"/>
                    </a:ext>
                  </a:extLst>
                </p:cNvPr>
                <p:cNvSpPr txBox="1"/>
                <p:nvPr/>
              </p:nvSpPr>
              <p:spPr>
                <a:xfrm>
                  <a:off x="3487891" y="1378668"/>
                  <a:ext cx="685800" cy="20928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spcBef>
                      <a:spcPts val="200"/>
                    </a:spcBef>
                  </a:pPr>
                  <a:r>
                    <a:rPr lang="en-US" sz="1000" dirty="0"/>
                    <a:t>250</a:t>
                  </a:r>
                </a:p>
                <a:p>
                  <a:pPr>
                    <a:spcBef>
                      <a:spcPts val="200"/>
                    </a:spcBef>
                  </a:pPr>
                  <a:r>
                    <a:rPr lang="en-US" sz="1000" dirty="0"/>
                    <a:t>150</a:t>
                  </a:r>
                </a:p>
                <a:p>
                  <a:pPr>
                    <a:lnSpc>
                      <a:spcPct val="150000"/>
                    </a:lnSpc>
                    <a:spcBef>
                      <a:spcPts val="200"/>
                    </a:spcBef>
                  </a:pPr>
                  <a:r>
                    <a:rPr lang="en-US" sz="1000" dirty="0"/>
                    <a:t>100</a:t>
                  </a:r>
                </a:p>
                <a:p>
                  <a:pPr>
                    <a:lnSpc>
                      <a:spcPct val="150000"/>
                    </a:lnSpc>
                    <a:spcBef>
                      <a:spcPts val="200"/>
                    </a:spcBef>
                    <a:spcAft>
                      <a:spcPts val="400"/>
                    </a:spcAft>
                  </a:pPr>
                  <a:r>
                    <a:rPr lang="en-US" sz="1000" dirty="0"/>
                    <a:t>75</a:t>
                  </a:r>
                </a:p>
                <a:p>
                  <a:pPr>
                    <a:spcBef>
                      <a:spcPts val="400"/>
                    </a:spcBef>
                    <a:spcAft>
                      <a:spcPts val="400"/>
                    </a:spcAft>
                  </a:pPr>
                  <a:r>
                    <a:rPr lang="en-US" sz="1000" dirty="0"/>
                    <a:t>50</a:t>
                  </a:r>
                </a:p>
                <a:p>
                  <a:pPr>
                    <a:spcBef>
                      <a:spcPts val="200"/>
                    </a:spcBef>
                    <a:spcAft>
                      <a:spcPts val="200"/>
                    </a:spcAft>
                  </a:pPr>
                  <a:r>
                    <a:rPr lang="en-US" sz="1000" dirty="0"/>
                    <a:t>37</a:t>
                  </a:r>
                </a:p>
                <a:p>
                  <a:pPr>
                    <a:spcBef>
                      <a:spcPts val="200"/>
                    </a:spcBef>
                    <a:spcAft>
                      <a:spcPts val="600"/>
                    </a:spcAft>
                  </a:pPr>
                  <a:endParaRPr lang="en-US" sz="1000" dirty="0"/>
                </a:p>
                <a:p>
                  <a:pPr>
                    <a:spcBef>
                      <a:spcPts val="200"/>
                    </a:spcBef>
                    <a:spcAft>
                      <a:spcPts val="200"/>
                    </a:spcAft>
                  </a:pPr>
                  <a:r>
                    <a:rPr lang="en-US" sz="1000" dirty="0"/>
                    <a:t>25</a:t>
                  </a:r>
                </a:p>
                <a:p>
                  <a:pPr>
                    <a:spcBef>
                      <a:spcPts val="200"/>
                    </a:spcBef>
                    <a:spcAft>
                      <a:spcPts val="200"/>
                    </a:spcAft>
                  </a:pPr>
                  <a:r>
                    <a:rPr lang="en-US" sz="1000" dirty="0"/>
                    <a:t>20</a:t>
                  </a:r>
                </a:p>
              </p:txBody>
            </p:sp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1A7B92B1-3CF5-4071-865D-F16AC37C056C}"/>
                    </a:ext>
                  </a:extLst>
                </p:cNvPr>
                <p:cNvGrpSpPr/>
                <p:nvPr/>
              </p:nvGrpSpPr>
              <p:grpSpPr>
                <a:xfrm>
                  <a:off x="7807877" y="1848018"/>
                  <a:ext cx="2705565" cy="383158"/>
                  <a:chOff x="7807877" y="1848018"/>
                  <a:chExt cx="2705565" cy="383158"/>
                </a:xfrm>
              </p:grpSpPr>
              <p:cxnSp>
                <p:nvCxnSpPr>
                  <p:cNvPr id="17" name="Straight Arrow Connector 16">
                    <a:extLst>
                      <a:ext uri="{FF2B5EF4-FFF2-40B4-BE49-F238E27FC236}">
                        <a16:creationId xmlns:a16="http://schemas.microsoft.com/office/drawing/2014/main" id="{D1349406-EE31-475C-A88B-EEAD9DE9D7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7807877" y="2025819"/>
                    <a:ext cx="1216670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E67BACC3-582D-4571-98B8-6ED9B4D618FA}"/>
                      </a:ext>
                    </a:extLst>
                  </p:cNvPr>
                  <p:cNvSpPr txBox="1"/>
                  <p:nvPr/>
                </p:nvSpPr>
                <p:spPr>
                  <a:xfrm>
                    <a:off x="9128780" y="1848018"/>
                    <a:ext cx="1384662" cy="3831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dirty="0"/>
                      <a:t>DRP1</a:t>
                    </a:r>
                  </a:p>
                </p:txBody>
              </p:sp>
            </p:grpSp>
          </p:grpSp>
        </p:grp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74E1B23-1C39-633B-14FE-4C3961C7E4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90094" y="2390870"/>
              <a:ext cx="3935304" cy="8839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87948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AC31A40-C5EA-49AA-8B8B-BB98736E6B6A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OPA1 Mi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97E368-9FE1-48CB-8E92-93CDD3D31A15}"/>
              </a:ext>
            </a:extLst>
          </p:cNvPr>
          <p:cNvSpPr txBox="1"/>
          <p:nvPr/>
        </p:nvSpPr>
        <p:spPr>
          <a:xfrm>
            <a:off x="728668" y="4842783"/>
            <a:ext cx="113675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te: 10-21-2019; </a:t>
            </a:r>
          </a:p>
          <a:p>
            <a:r>
              <a:rPr lang="en-US" dirty="0"/>
              <a:t>10ug total protein, 12% gel, Transfer ON 30mV, </a:t>
            </a:r>
          </a:p>
          <a:p>
            <a:r>
              <a:rPr lang="en-US" dirty="0"/>
              <a:t>1st Antibody: OPA1 anti Rabbit (ON 1:1000) 86-100kDa, </a:t>
            </a:r>
            <a:r>
              <a:rPr lang="en-US" dirty="0" err="1"/>
              <a:t>Novusbio</a:t>
            </a:r>
            <a:r>
              <a:rPr lang="en-US" dirty="0"/>
              <a:t> NB#110-55290; 2nd Antibody: GAR (1:5000)   </a:t>
            </a:r>
          </a:p>
          <a:p>
            <a:r>
              <a:rPr lang="en-US" dirty="0"/>
              <a:t>Developed:  10sec ECL, KQ</a:t>
            </a:r>
          </a:p>
          <a:p>
            <a:r>
              <a:rPr lang="en-US" dirty="0"/>
              <a:t>NO: normoxia; HO: hyperoxia; WT: wild type; KO: Knockout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0EDFFF9-4C50-7ECB-BDAC-A0DB12243ACB}"/>
              </a:ext>
            </a:extLst>
          </p:cNvPr>
          <p:cNvGrpSpPr/>
          <p:nvPr/>
        </p:nvGrpSpPr>
        <p:grpSpPr>
          <a:xfrm>
            <a:off x="2199355" y="1047558"/>
            <a:ext cx="5534977" cy="3360127"/>
            <a:chOff x="3776255" y="1098683"/>
            <a:chExt cx="5534977" cy="3360127"/>
          </a:xfrm>
        </p:grpSpPr>
        <p:pic>
          <p:nvPicPr>
            <p:cNvPr id="16" name="Picture 15" descr="A close-up of a white sheet&#10;&#10;AI-generated content may be incorrect.">
              <a:extLst>
                <a:ext uri="{FF2B5EF4-FFF2-40B4-BE49-F238E27FC236}">
                  <a16:creationId xmlns:a16="http://schemas.microsoft.com/office/drawing/2014/main" id="{DAFA0DF9-0EA6-A5D9-421C-8A6A5A3685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1030" y="1098683"/>
              <a:ext cx="5350202" cy="325787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18FB203-2586-4DD7-82A8-9F2C3F5B6B18}"/>
                </a:ext>
              </a:extLst>
            </p:cNvPr>
            <p:cNvSpPr txBox="1"/>
            <p:nvPr/>
          </p:nvSpPr>
          <p:spPr>
            <a:xfrm>
              <a:off x="3776255" y="1288711"/>
              <a:ext cx="685800" cy="3170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200"/>
                </a:spcBef>
              </a:pPr>
              <a:r>
                <a:rPr lang="en-US" sz="1000" dirty="0"/>
                <a:t>250</a:t>
              </a:r>
            </a:p>
            <a:p>
              <a:pPr>
                <a:spcBef>
                  <a:spcPts val="200"/>
                </a:spcBef>
              </a:pPr>
              <a:r>
                <a:rPr lang="en-US" sz="1000" dirty="0"/>
                <a:t>150</a:t>
              </a:r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100</a:t>
              </a:r>
            </a:p>
            <a:p>
              <a:pPr>
                <a:spcBef>
                  <a:spcPts val="200"/>
                </a:spcBef>
              </a:pPr>
              <a:r>
                <a:rPr lang="en-US" sz="1000" dirty="0"/>
                <a:t>75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r>
                <a:rPr lang="en-US" sz="1000" dirty="0"/>
                <a:t>50</a:t>
              </a:r>
            </a:p>
            <a:p>
              <a:endParaRPr lang="en-US" sz="1000" dirty="0"/>
            </a:p>
            <a:p>
              <a:endParaRPr lang="en-US" sz="1000" dirty="0"/>
            </a:p>
            <a:p>
              <a:r>
                <a:rPr lang="en-US" sz="1000" dirty="0"/>
                <a:t>37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25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20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150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866BA8D-08EC-33F0-3C0E-DA8D76F0B2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82797" y="2363157"/>
              <a:ext cx="4728435" cy="883997"/>
            </a:xfrm>
            <a:prstGeom prst="rect">
              <a:avLst/>
            </a:prstGeom>
          </p:spPr>
        </p:pic>
      </p:grp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4452776-F1E3-5145-C228-B2E1A6E95E8B}"/>
              </a:ext>
            </a:extLst>
          </p:cNvPr>
          <p:cNvCxnSpPr>
            <a:cxnSpLocks/>
          </p:cNvCxnSpPr>
          <p:nvPr/>
        </p:nvCxnSpPr>
        <p:spPr>
          <a:xfrm flipH="1">
            <a:off x="6925251" y="1789108"/>
            <a:ext cx="1618161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0C7E844A-9B21-C867-5842-FAF28EF6C22B}"/>
              </a:ext>
            </a:extLst>
          </p:cNvPr>
          <p:cNvSpPr txBox="1"/>
          <p:nvPr/>
        </p:nvSpPr>
        <p:spPr>
          <a:xfrm>
            <a:off x="8876843" y="1518984"/>
            <a:ext cx="1349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PA1</a:t>
            </a:r>
          </a:p>
        </p:txBody>
      </p:sp>
    </p:spTree>
    <p:extLst>
      <p:ext uri="{BB962C8B-B14F-4D97-AF65-F5344CB8AC3E}">
        <p14:creationId xmlns:p14="http://schemas.microsoft.com/office/powerpoint/2010/main" val="34420985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9809B9-CDF1-475F-AE71-7AFA59B4BBDD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</a:t>
            </a:r>
            <a:r>
              <a:rPr lang="en-US" sz="2000" dirty="0" err="1"/>
              <a:t>Mitofusin</a:t>
            </a:r>
            <a:r>
              <a:rPr lang="en-US" sz="2000" dirty="0"/>
              <a:t> 1 and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741A9C7-675B-4D3E-8B9E-A94C403F24AF}"/>
              </a:ext>
            </a:extLst>
          </p:cNvPr>
          <p:cNvSpPr txBox="1"/>
          <p:nvPr/>
        </p:nvSpPr>
        <p:spPr>
          <a:xfrm>
            <a:off x="842629" y="4503038"/>
            <a:ext cx="1013017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10-23-2019; 10ug  total protein </a:t>
            </a:r>
          </a:p>
          <a:p>
            <a:r>
              <a:rPr lang="en-US" dirty="0"/>
              <a:t>12% gel, Transfer ON 30mV, </a:t>
            </a:r>
          </a:p>
          <a:p>
            <a:r>
              <a:rPr lang="en-US" dirty="0"/>
              <a:t>1st Antibody: MFN1 anti Mouse (ON 1:1000) 50-75kDa, Abcam ab57602; 2nd Antibody: GAM (1:5000)after several years of Abcam selling this antibody as MFN1 now it is sold as MFN1 and2    </a:t>
            </a:r>
          </a:p>
          <a:p>
            <a:r>
              <a:rPr lang="en-US" dirty="0"/>
              <a:t>Developed: KQ 10sec ECL</a:t>
            </a:r>
          </a:p>
          <a:p>
            <a:r>
              <a:rPr lang="en-US" dirty="0"/>
              <a:t>NO: normoxia; HO: hyperoxia; WT: wild type; KO: Knockout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C722DA6-253D-594D-DD6A-FED9E616D4B4}"/>
              </a:ext>
            </a:extLst>
          </p:cNvPr>
          <p:cNvGrpSpPr/>
          <p:nvPr/>
        </p:nvGrpSpPr>
        <p:grpSpPr>
          <a:xfrm>
            <a:off x="3428021" y="855779"/>
            <a:ext cx="7759898" cy="3169258"/>
            <a:chOff x="3428019" y="855779"/>
            <a:chExt cx="7759898" cy="3169258"/>
          </a:xfrm>
        </p:grpSpPr>
        <p:pic>
          <p:nvPicPr>
            <p:cNvPr id="12" name="Picture 11" descr="A close-up of a white sheet&#10;&#10;AI-generated content may be incorrect.">
              <a:extLst>
                <a:ext uri="{FF2B5EF4-FFF2-40B4-BE49-F238E27FC236}">
                  <a16:creationId xmlns:a16="http://schemas.microsoft.com/office/drawing/2014/main" id="{60FA62D4-825C-3035-921C-48B068FAF0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8185" y="855779"/>
              <a:ext cx="5070814" cy="3169258"/>
            </a:xfrm>
            <a:prstGeom prst="rect">
              <a:avLst/>
            </a:prstGeom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D7DCB8E-D0B1-4EDF-A55A-AF6239BCD197}"/>
                </a:ext>
              </a:extLst>
            </p:cNvPr>
            <p:cNvGrpSpPr/>
            <p:nvPr/>
          </p:nvGrpSpPr>
          <p:grpSpPr>
            <a:xfrm>
              <a:off x="3428019" y="1188363"/>
              <a:ext cx="7759898" cy="2836674"/>
              <a:chOff x="3428020" y="1152236"/>
              <a:chExt cx="7759898" cy="2836674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A9FC24B6-C3D3-45F6-B66A-2E7C07D910AA}"/>
                  </a:ext>
                </a:extLst>
              </p:cNvPr>
              <p:cNvSpPr txBox="1"/>
              <p:nvPr/>
            </p:nvSpPr>
            <p:spPr>
              <a:xfrm>
                <a:off x="3428020" y="1152236"/>
                <a:ext cx="685800" cy="28366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250</a:t>
                </a:r>
              </a:p>
              <a:p>
                <a:r>
                  <a:rPr lang="en-US" sz="1000" dirty="0"/>
                  <a:t>150</a:t>
                </a:r>
              </a:p>
              <a:p>
                <a:r>
                  <a:rPr lang="en-US" sz="1000" dirty="0"/>
                  <a:t>100</a:t>
                </a:r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75</a:t>
                </a:r>
              </a:p>
              <a:p>
                <a:pPr>
                  <a:lnSpc>
                    <a:spcPct val="200000"/>
                  </a:lnSpc>
                  <a:spcBef>
                    <a:spcPts val="200"/>
                  </a:spcBef>
                </a:pPr>
                <a:r>
                  <a:rPr lang="en-US" sz="1000" dirty="0"/>
                  <a:t>5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37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25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2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0</a:t>
                </a:r>
              </a:p>
            </p:txBody>
          </p: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F79950C4-710A-42E2-95A4-097410C6DE72}"/>
                  </a:ext>
                </a:extLst>
              </p:cNvPr>
              <p:cNvGrpSpPr/>
              <p:nvPr/>
            </p:nvGrpSpPr>
            <p:grpSpPr>
              <a:xfrm>
                <a:off x="7860187" y="1795029"/>
                <a:ext cx="3327731" cy="369332"/>
                <a:chOff x="7860187" y="1795029"/>
                <a:chExt cx="3327731" cy="369332"/>
              </a:xfrm>
            </p:grpSpPr>
            <p:cxnSp>
              <p:nvCxnSpPr>
                <p:cNvPr id="15" name="Straight Arrow Connector 14">
                  <a:extLst>
                    <a:ext uri="{FF2B5EF4-FFF2-40B4-BE49-F238E27FC236}">
                      <a16:creationId xmlns:a16="http://schemas.microsoft.com/office/drawing/2014/main" id="{639775D5-3EC8-41B0-853A-18CFD64CED91}"/>
                    </a:ext>
                  </a:extLst>
                </p:cNvPr>
                <p:cNvCxnSpPr/>
                <p:nvPr/>
              </p:nvCxnSpPr>
              <p:spPr>
                <a:xfrm flipH="1">
                  <a:off x="7860187" y="1979695"/>
                  <a:ext cx="2011680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5A5C95F4-0834-47A3-8999-E9DF018EAE2D}"/>
                    </a:ext>
                  </a:extLst>
                </p:cNvPr>
                <p:cNvSpPr txBox="1"/>
                <p:nvPr/>
              </p:nvSpPr>
              <p:spPr>
                <a:xfrm>
                  <a:off x="9871867" y="1795029"/>
                  <a:ext cx="131605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MFN1&amp;2</a:t>
                  </a:r>
                </a:p>
              </p:txBody>
            </p:sp>
          </p:grpSp>
        </p:grp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665E71C-9080-E839-ABD1-28D74E6030B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29869" y="2535188"/>
              <a:ext cx="4210826" cy="8839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843106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86231C1-2ED8-4C67-875B-A90613EDC686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PINK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9F6AEF8-5633-4A06-82F1-17B4DA7BC79A}"/>
              </a:ext>
            </a:extLst>
          </p:cNvPr>
          <p:cNvSpPr txBox="1"/>
          <p:nvPr/>
        </p:nvSpPr>
        <p:spPr>
          <a:xfrm>
            <a:off x="529770" y="4770371"/>
            <a:ext cx="1064812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06-20-2018  </a:t>
            </a:r>
          </a:p>
          <a:p>
            <a:r>
              <a:rPr lang="en-US" dirty="0"/>
              <a:t>Protein: 10ug 12% gel, Transfer ON 30mV, </a:t>
            </a:r>
          </a:p>
          <a:p>
            <a:r>
              <a:rPr lang="en-US" dirty="0"/>
              <a:t>1st Antibody: PINK1 anti Rabbit (ON 1:1000), CST #6949, 50-60 </a:t>
            </a:r>
            <a:r>
              <a:rPr lang="en-US" dirty="0" err="1"/>
              <a:t>kDa</a:t>
            </a:r>
            <a:r>
              <a:rPr lang="en-US" dirty="0"/>
              <a:t>, 2nd Antibody: GAR (1:5000)  </a:t>
            </a:r>
          </a:p>
          <a:p>
            <a:r>
              <a:rPr lang="en-US" dirty="0"/>
              <a:t> Developed 10sec ECL, 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  <a:p>
            <a:endParaRPr lang="en-US" dirty="0"/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253A6E7-FCED-EC16-FBBB-D02433430235}"/>
              </a:ext>
            </a:extLst>
          </p:cNvPr>
          <p:cNvGrpSpPr/>
          <p:nvPr/>
        </p:nvGrpSpPr>
        <p:grpSpPr>
          <a:xfrm>
            <a:off x="3121374" y="1225366"/>
            <a:ext cx="6689787" cy="2743702"/>
            <a:chOff x="3121375" y="867147"/>
            <a:chExt cx="6689787" cy="2743702"/>
          </a:xfrm>
        </p:grpSpPr>
        <p:pic>
          <p:nvPicPr>
            <p:cNvPr id="4" name="Picture 3" descr="A close-up of a test&#10;&#10;AI-generated content may be incorrect.">
              <a:extLst>
                <a:ext uri="{FF2B5EF4-FFF2-40B4-BE49-F238E27FC236}">
                  <a16:creationId xmlns:a16="http://schemas.microsoft.com/office/drawing/2014/main" id="{8A95AB4A-AB4F-3DC1-13D1-2D26C64426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1375" y="867147"/>
              <a:ext cx="4546706" cy="2743702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47195BE-6F3D-4400-B302-8ECE8AEF617E}"/>
                </a:ext>
              </a:extLst>
            </p:cNvPr>
            <p:cNvSpPr txBox="1"/>
            <p:nvPr/>
          </p:nvSpPr>
          <p:spPr>
            <a:xfrm>
              <a:off x="3121375" y="1016824"/>
              <a:ext cx="685800" cy="2580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50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50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0</a:t>
              </a:r>
            </a:p>
            <a:p>
              <a:pPr marL="0" marR="0" lvl="0" indent="0" algn="l" defTabSz="914400" rtl="0" eaLnBrk="1" fontAlgn="auto" latinLnBrk="0" hangingPunct="1">
                <a:spcBef>
                  <a:spcPts val="1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75</a:t>
              </a:r>
            </a:p>
            <a:p>
              <a:pPr marL="0" marR="0" lvl="0" indent="0" algn="l" defTabSz="914400" rtl="0" eaLnBrk="1" fontAlgn="auto" latinLnBrk="0" hangingPunct="1">
                <a:spcBef>
                  <a:spcPts val="1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</a:p>
            <a:p>
              <a:pPr marL="0" marR="0" lvl="0" indent="0" algn="l" defTabSz="914400" rtl="0" eaLnBrk="1" fontAlgn="auto" latinLnBrk="0" hangingPunct="1"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7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5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lang="en-US" sz="1000" dirty="0">
                <a:solidFill>
                  <a:prstClr val="black"/>
                </a:solidFill>
                <a:latin typeface="Calibri" panose="020F0502020204030204"/>
              </a:endParaRP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5</a:t>
              </a:r>
            </a:p>
            <a:p>
              <a:pPr marL="0" marR="0" lvl="0" indent="0" algn="l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>
                  <a:solidFill>
                    <a:prstClr val="black"/>
                  </a:solidFill>
                  <a:latin typeface="Calibri" panose="020F0502020204030204"/>
                </a:rPr>
                <a:t>10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DC6ECA5-84BD-093D-1D37-E6AD307EBBC2}"/>
                </a:ext>
              </a:extLst>
            </p:cNvPr>
            <p:cNvGrpSpPr/>
            <p:nvPr/>
          </p:nvGrpSpPr>
          <p:grpSpPr>
            <a:xfrm>
              <a:off x="3661001" y="2719421"/>
              <a:ext cx="3414917" cy="802146"/>
              <a:chOff x="4362051" y="2390560"/>
              <a:chExt cx="3894568" cy="1012315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1C2CA6D7-4AD9-6EAB-1A99-B6832E25A87B}"/>
                  </a:ext>
                </a:extLst>
              </p:cNvPr>
              <p:cNvGrpSpPr/>
              <p:nvPr/>
            </p:nvGrpSpPr>
            <p:grpSpPr>
              <a:xfrm>
                <a:off x="4362051" y="2390560"/>
                <a:ext cx="3794465" cy="0"/>
                <a:chOff x="5189365" y="4522981"/>
                <a:chExt cx="3794465" cy="0"/>
              </a:xfrm>
            </p:grpSpPr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5D30A6DE-4F33-FC92-7106-1F3978E0EE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89365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96AAF6F5-9DF6-DF9F-3FB7-13A2CD13CA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64752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D1E0B6C0-3730-3D59-98AA-C20F124455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31259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080ADB94-743F-48C8-A7F7-1C8F8B03ED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23649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1FCD5E0-D1ED-7360-64C3-A96B83D19F99}"/>
                  </a:ext>
                </a:extLst>
              </p:cNvPr>
              <p:cNvSpPr txBox="1"/>
              <p:nvPr/>
            </p:nvSpPr>
            <p:spPr>
              <a:xfrm>
                <a:off x="4421968" y="2470674"/>
                <a:ext cx="3834651" cy="9322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-NO      BMI1-KO      WT-HO      BMI1-KO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NO 	                    HO</a:t>
                </a:r>
              </a:p>
              <a:p>
                <a:endParaRPr lang="en-US" dirty="0"/>
              </a:p>
            </p:txBody>
          </p:sp>
        </p:grp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9D9C89D3-30DE-3522-DF61-170900924B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887062" y="1956193"/>
              <a:ext cx="187152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46A64E8-2DE0-5B23-920D-2FFD766527D7}"/>
                </a:ext>
              </a:extLst>
            </p:cNvPr>
            <p:cNvSpPr txBox="1"/>
            <p:nvPr/>
          </p:nvSpPr>
          <p:spPr>
            <a:xfrm>
              <a:off x="8811304" y="1771527"/>
              <a:ext cx="9998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INK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97653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08BFC78-0C6A-4F8A-BE85-25B97D0E2403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Parkin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0CB676A-D93A-1267-94C4-777465D3F0F2}"/>
              </a:ext>
            </a:extLst>
          </p:cNvPr>
          <p:cNvGrpSpPr/>
          <p:nvPr/>
        </p:nvGrpSpPr>
        <p:grpSpPr>
          <a:xfrm>
            <a:off x="2880768" y="511023"/>
            <a:ext cx="7807375" cy="3389698"/>
            <a:chOff x="2880768" y="511023"/>
            <a:chExt cx="7807375" cy="3389698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1E66A56B-F157-D4B6-3A45-F71F18532720}"/>
                </a:ext>
              </a:extLst>
            </p:cNvPr>
            <p:cNvGrpSpPr/>
            <p:nvPr/>
          </p:nvGrpSpPr>
          <p:grpSpPr>
            <a:xfrm>
              <a:off x="2880768" y="511023"/>
              <a:ext cx="5704082" cy="3389698"/>
              <a:chOff x="2880768" y="511023"/>
              <a:chExt cx="5704082" cy="3389698"/>
            </a:xfrm>
          </p:grpSpPr>
          <p:pic>
            <p:nvPicPr>
              <p:cNvPr id="4" name="Picture 3" descr="A close-up of a white plastic bag&#10;&#10;AI-generated content may be incorrect.">
                <a:extLst>
                  <a:ext uri="{FF2B5EF4-FFF2-40B4-BE49-F238E27FC236}">
                    <a16:creationId xmlns:a16="http://schemas.microsoft.com/office/drawing/2014/main" id="{20CD1B25-E299-840D-9953-BB531C60AA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80768" y="511023"/>
                <a:ext cx="5704082" cy="3389698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BC998BB-8EC1-E6E6-91B7-903CAB510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738490" y="2191267"/>
                <a:ext cx="4456925" cy="883997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B46BCD0-26BF-35A9-EE51-ACF0730075FC}"/>
                  </a:ext>
                </a:extLst>
              </p:cNvPr>
              <p:cNvSpPr txBox="1"/>
              <p:nvPr/>
            </p:nvSpPr>
            <p:spPr>
              <a:xfrm>
                <a:off x="2880768" y="680589"/>
                <a:ext cx="685800" cy="31700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ts val="200"/>
                  </a:spcBef>
                </a:pPr>
                <a:r>
                  <a:rPr lang="en-US" sz="1000" dirty="0"/>
                  <a:t>25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0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75</a:t>
                </a:r>
              </a:p>
              <a:p>
                <a:pPr>
                  <a:spcBef>
                    <a:spcPts val="300"/>
                  </a:spcBef>
                  <a:spcAft>
                    <a:spcPts val="200"/>
                  </a:spcAft>
                </a:pPr>
                <a:endParaRPr lang="en-US" sz="1000" dirty="0"/>
              </a:p>
              <a:p>
                <a:pPr>
                  <a:spcBef>
                    <a:spcPts val="300"/>
                  </a:spcBef>
                  <a:spcAft>
                    <a:spcPts val="200"/>
                  </a:spcAft>
                </a:pPr>
                <a:r>
                  <a:rPr lang="en-US" sz="1000" dirty="0"/>
                  <a:t>50</a:t>
                </a:r>
              </a:p>
              <a:p>
                <a:pPr>
                  <a:spcBef>
                    <a:spcPts val="300"/>
                  </a:spcBef>
                  <a:spcAft>
                    <a:spcPts val="200"/>
                  </a:spcAft>
                </a:pPr>
                <a:endParaRPr lang="en-US" sz="1000" dirty="0"/>
              </a:p>
              <a:p>
                <a:pPr>
                  <a:spcBef>
                    <a:spcPts val="300"/>
                  </a:spcBef>
                  <a:spcAft>
                    <a:spcPts val="200"/>
                  </a:spcAft>
                </a:pPr>
                <a:r>
                  <a:rPr lang="en-US" sz="1000" dirty="0"/>
                  <a:t>37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25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2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0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51C02B2-FC0B-44DC-9EE5-D3B00B005AE3}"/>
                </a:ext>
              </a:extLst>
            </p:cNvPr>
            <p:cNvGrpSpPr/>
            <p:nvPr/>
          </p:nvGrpSpPr>
          <p:grpSpPr>
            <a:xfrm>
              <a:off x="7720153" y="1706991"/>
              <a:ext cx="2967990" cy="369332"/>
              <a:chOff x="7926066" y="2367762"/>
              <a:chExt cx="2967990" cy="369332"/>
            </a:xfrm>
          </p:grpSpPr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0D8FAB10-0DE0-4769-8CD5-9A2EC578E4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926066" y="2552428"/>
                <a:ext cx="1618161" cy="0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2A20B44-1B1B-454F-B409-F18B445641AE}"/>
                  </a:ext>
                </a:extLst>
              </p:cNvPr>
              <p:cNvSpPr txBox="1"/>
              <p:nvPr/>
            </p:nvSpPr>
            <p:spPr>
              <a:xfrm>
                <a:off x="9544227" y="2367762"/>
                <a:ext cx="13498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Parkin</a:t>
                </a:r>
              </a:p>
            </p:txBody>
          </p: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E487FE38-BD32-4540-9371-E42ED7F53D08}"/>
              </a:ext>
            </a:extLst>
          </p:cNvPr>
          <p:cNvSpPr txBox="1"/>
          <p:nvPr/>
        </p:nvSpPr>
        <p:spPr>
          <a:xfrm>
            <a:off x="341235" y="4828653"/>
            <a:ext cx="11016125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03-05-2020 </a:t>
            </a:r>
          </a:p>
          <a:p>
            <a:r>
              <a:rPr lang="en-US" dirty="0"/>
              <a:t>Protein: 10ug, 12% gel, Transfer ON 30mV, </a:t>
            </a:r>
          </a:p>
          <a:p>
            <a:r>
              <a:rPr lang="en-US" dirty="0"/>
              <a:t>1st Antibody: Parkin anti Mouse (ON 1:1000), CST #4211, 50 kDa,2nd Antibody: GAM (1:5000)  </a:t>
            </a:r>
          </a:p>
          <a:p>
            <a:r>
              <a:rPr lang="en-US" dirty="0"/>
              <a:t>Developed 1min ECL, KQ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94316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A00F3D6D-F28C-4E51-877F-432BE23055AF}"/>
              </a:ext>
            </a:extLst>
          </p:cNvPr>
          <p:cNvSpPr/>
          <p:nvPr/>
        </p:nvSpPr>
        <p:spPr>
          <a:xfrm>
            <a:off x="448443" y="4984828"/>
            <a:ext cx="1059533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Date: 02-27-2020</a:t>
            </a:r>
          </a:p>
          <a:p>
            <a:r>
              <a:rPr lang="en-US" dirty="0"/>
              <a:t>Protein: 10ug   </a:t>
            </a:r>
          </a:p>
          <a:p>
            <a:r>
              <a:rPr lang="en-US" dirty="0"/>
              <a:t>12% gel, Transfer ON 30mV,</a:t>
            </a:r>
          </a:p>
          <a:p>
            <a:r>
              <a:rPr lang="en-US" dirty="0"/>
              <a:t>1st Antibody: </a:t>
            </a:r>
            <a:r>
              <a:rPr lang="en-US" dirty="0" err="1"/>
              <a:t>pAKT</a:t>
            </a:r>
            <a:r>
              <a:rPr lang="en-US" dirty="0"/>
              <a:t> (ser 473) anti Rabbit (ON 1:5000) 60KDa, CST #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4060; </a:t>
            </a:r>
            <a:r>
              <a:rPr lang="en-US" dirty="0"/>
              <a:t>2nd Antibody: GAR (1:5000)   </a:t>
            </a:r>
          </a:p>
          <a:p>
            <a:r>
              <a:rPr lang="en-US" dirty="0"/>
              <a:t>Developed:  1 min ECL KQ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F88856-B198-40DE-AB69-97F5092B333E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p-AKT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3F30703-B415-52AA-2F75-6AE932600448}"/>
              </a:ext>
            </a:extLst>
          </p:cNvPr>
          <p:cNvGrpSpPr/>
          <p:nvPr/>
        </p:nvGrpSpPr>
        <p:grpSpPr>
          <a:xfrm>
            <a:off x="2878947" y="1241066"/>
            <a:ext cx="7145270" cy="3195693"/>
            <a:chOff x="2878947" y="1241066"/>
            <a:chExt cx="7145270" cy="3195693"/>
          </a:xfrm>
        </p:grpSpPr>
        <p:pic>
          <p:nvPicPr>
            <p:cNvPr id="3" name="Picture 2" descr="A close-up of a test&#10;&#10;AI-generated content may be incorrect.">
              <a:extLst>
                <a:ext uri="{FF2B5EF4-FFF2-40B4-BE49-F238E27FC236}">
                  <a16:creationId xmlns:a16="http://schemas.microsoft.com/office/drawing/2014/main" id="{5914F27F-8AF8-1902-4EEE-6135EC0F8A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8947" y="1241066"/>
              <a:ext cx="5297783" cy="3144447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D392EF6-52CC-4CA1-8020-E6E7C4FE5540}"/>
                </a:ext>
              </a:extLst>
            </p:cNvPr>
            <p:cNvSpPr txBox="1"/>
            <p:nvPr/>
          </p:nvSpPr>
          <p:spPr>
            <a:xfrm>
              <a:off x="3092522" y="1369253"/>
              <a:ext cx="685800" cy="3067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200"/>
                </a:spcBef>
              </a:pPr>
              <a:r>
                <a:rPr lang="en-US" sz="1000" dirty="0"/>
                <a:t>250</a:t>
              </a:r>
            </a:p>
            <a:p>
              <a:pPr>
                <a:spcBef>
                  <a:spcPts val="200"/>
                </a:spcBef>
              </a:pPr>
              <a:r>
                <a:rPr lang="en-US" sz="1000" dirty="0"/>
                <a:t>150</a:t>
              </a:r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100</a:t>
              </a:r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75</a:t>
              </a:r>
            </a:p>
            <a:p>
              <a:pPr>
                <a:lnSpc>
                  <a:spcPct val="200000"/>
                </a:lnSpc>
                <a:spcBef>
                  <a:spcPts val="200"/>
                </a:spcBef>
              </a:pPr>
              <a:r>
                <a:rPr lang="en-US" sz="1000" dirty="0"/>
                <a:t>50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37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25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20</a:t>
              </a:r>
            </a:p>
            <a:p>
              <a:endParaRPr lang="en-US" sz="1000" dirty="0"/>
            </a:p>
            <a:p>
              <a:r>
                <a:rPr lang="en-US" sz="1000" dirty="0"/>
                <a:t>15</a:t>
              </a:r>
            </a:p>
            <a:p>
              <a:r>
                <a:rPr lang="en-US" sz="1000" dirty="0"/>
                <a:t>10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4626A5C-DB3A-D8E2-FFF5-FCB2E40679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47143" y="2217496"/>
              <a:ext cx="1603387" cy="164606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E6BFB68F-8EB1-3CB0-E7C1-6B6F1B2FFF65}"/>
                </a:ext>
              </a:extLst>
            </p:cNvPr>
            <p:cNvGrpSpPr/>
            <p:nvPr/>
          </p:nvGrpSpPr>
          <p:grpSpPr>
            <a:xfrm>
              <a:off x="3706587" y="2963905"/>
              <a:ext cx="3976081" cy="719332"/>
              <a:chOff x="4362051" y="2390560"/>
              <a:chExt cx="3994755" cy="1095776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A7462BDA-0A97-0B3A-D414-25F820630B74}"/>
                  </a:ext>
                </a:extLst>
              </p:cNvPr>
              <p:cNvGrpSpPr/>
              <p:nvPr/>
            </p:nvGrpSpPr>
            <p:grpSpPr>
              <a:xfrm>
                <a:off x="4362051" y="2390560"/>
                <a:ext cx="3930914" cy="0"/>
                <a:chOff x="5189365" y="4522981"/>
                <a:chExt cx="3930914" cy="0"/>
              </a:xfrm>
            </p:grpSpPr>
            <p:cxnSp>
              <p:nvCxnSpPr>
                <p:cNvPr id="11" name="Straight Connector 10">
                  <a:extLst>
                    <a:ext uri="{FF2B5EF4-FFF2-40B4-BE49-F238E27FC236}">
                      <a16:creationId xmlns:a16="http://schemas.microsoft.com/office/drawing/2014/main" id="{343EC807-B1D1-072D-2277-0549327163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89365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E33F724A-72CB-6025-A2DD-1676CE2527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64752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9A39CDF3-FF88-ACBB-F220-05CE898F97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38469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B2F90359-E9D0-1A9F-13E4-1B1301E6D3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260098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E48B414-C7F7-01F5-3EFA-4EABB9A05959}"/>
                  </a:ext>
                </a:extLst>
              </p:cNvPr>
              <p:cNvSpPr txBox="1"/>
              <p:nvPr/>
            </p:nvSpPr>
            <p:spPr>
              <a:xfrm>
                <a:off x="4421969" y="2470673"/>
                <a:ext cx="3934837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-NO      BMI1-KO          WT-HO      BMI1-KO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	NO 		        HO</a:t>
                </a:r>
              </a:p>
              <a:p>
                <a:endParaRPr lang="en-US" dirty="0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88B88EB-8C13-48CB-662B-DAF6A15B7408}"/>
                </a:ext>
              </a:extLst>
            </p:cNvPr>
            <p:cNvSpPr txBox="1"/>
            <p:nvPr/>
          </p:nvSpPr>
          <p:spPr>
            <a:xfrm>
              <a:off x="9152546" y="2127903"/>
              <a:ext cx="87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547316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9E5CAB6-8F01-5224-54C5-BFDF06D5DD2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white paper&#10;&#10;AI-generated content may be incorrect.">
            <a:extLst>
              <a:ext uri="{FF2B5EF4-FFF2-40B4-BE49-F238E27FC236}">
                <a16:creationId xmlns:a16="http://schemas.microsoft.com/office/drawing/2014/main" id="{04DDD541-844C-9D66-5F82-8F338034E6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3298" y="1280515"/>
            <a:ext cx="5365404" cy="319538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A3395FA-88F8-7A98-6D88-B21D7B912314}"/>
              </a:ext>
            </a:extLst>
          </p:cNvPr>
          <p:cNvSpPr/>
          <p:nvPr/>
        </p:nvSpPr>
        <p:spPr>
          <a:xfrm>
            <a:off x="448443" y="4984828"/>
            <a:ext cx="1059533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Date: 10-21-2019</a:t>
            </a:r>
          </a:p>
          <a:p>
            <a:r>
              <a:rPr lang="en-US" dirty="0"/>
              <a:t>Protein: 10ug   </a:t>
            </a:r>
          </a:p>
          <a:p>
            <a:r>
              <a:rPr lang="en-US" dirty="0"/>
              <a:t>12% gel, Transfer ON 30mV,</a:t>
            </a:r>
          </a:p>
          <a:p>
            <a:r>
              <a:rPr lang="en-US" dirty="0"/>
              <a:t>1st Antibody: AKT (ser 473) anti Rabbit (ON 1:5000) 60KDa, CST #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4691; </a:t>
            </a:r>
            <a:r>
              <a:rPr lang="en-US" dirty="0"/>
              <a:t>2nd Antibody: GAR (1:5000)   </a:t>
            </a:r>
          </a:p>
          <a:p>
            <a:r>
              <a:rPr lang="en-US" dirty="0"/>
              <a:t>Developed:  1 min ECL KQ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FA5817C-C4A9-F605-7EF2-34774F9C3558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AKT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58BC79E-E5E5-E27B-9D1C-2B77EC03E4EB}"/>
              </a:ext>
            </a:extLst>
          </p:cNvPr>
          <p:cNvGrpSpPr/>
          <p:nvPr/>
        </p:nvGrpSpPr>
        <p:grpSpPr>
          <a:xfrm>
            <a:off x="3092522" y="1369253"/>
            <a:ext cx="7808388" cy="2657138"/>
            <a:chOff x="3092522" y="1369253"/>
            <a:chExt cx="7808388" cy="2657138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C3E25EC-B0F3-4F77-45DB-59CCD146DBD1}"/>
                </a:ext>
              </a:extLst>
            </p:cNvPr>
            <p:cNvSpPr txBox="1"/>
            <p:nvPr/>
          </p:nvSpPr>
          <p:spPr>
            <a:xfrm>
              <a:off x="3092522" y="1369253"/>
              <a:ext cx="685800" cy="2657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50</a:t>
              </a:r>
            </a:p>
            <a:p>
              <a:r>
                <a:rPr lang="en-US" sz="1000" dirty="0"/>
                <a:t>150</a:t>
              </a:r>
            </a:p>
            <a:p>
              <a:r>
                <a:rPr lang="en-US" sz="1000" dirty="0"/>
                <a:t>100</a:t>
              </a:r>
            </a:p>
            <a:p>
              <a:r>
                <a:rPr lang="en-US" sz="1000" dirty="0"/>
                <a:t>75</a:t>
              </a:r>
            </a:p>
            <a:p>
              <a:pPr>
                <a:lnSpc>
                  <a:spcPct val="200000"/>
                </a:lnSpc>
                <a:spcBef>
                  <a:spcPts val="200"/>
                </a:spcBef>
              </a:pPr>
              <a:r>
                <a:rPr lang="en-US" sz="1000" dirty="0"/>
                <a:t>50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37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lnSpc>
                  <a:spcPct val="150000"/>
                </a:lnSpc>
                <a:spcBef>
                  <a:spcPts val="200"/>
                </a:spcBef>
              </a:pPr>
              <a:r>
                <a:rPr lang="en-US" sz="1000" dirty="0"/>
                <a:t>25</a:t>
              </a:r>
            </a:p>
            <a:p>
              <a:pPr>
                <a:spcBef>
                  <a:spcPts val="200"/>
                </a:spcBef>
              </a:pPr>
              <a:endParaRPr lang="en-US" sz="1000" dirty="0"/>
            </a:p>
            <a:p>
              <a:pPr>
                <a:spcBef>
                  <a:spcPts val="200"/>
                </a:spcBef>
              </a:pPr>
              <a:r>
                <a:rPr lang="en-US" sz="1000" dirty="0"/>
                <a:t>20</a:t>
              </a:r>
            </a:p>
            <a:p>
              <a:endParaRPr lang="en-US" sz="1000" dirty="0"/>
            </a:p>
            <a:p>
              <a:r>
                <a:rPr lang="en-US" sz="1000" dirty="0"/>
                <a:t>15</a:t>
              </a:r>
            </a:p>
            <a:p>
              <a:r>
                <a:rPr lang="en-US" sz="1000" dirty="0"/>
                <a:t>10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E1C652A-0D8A-EA93-31E7-DDD6DEEB491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800583" y="2115133"/>
              <a:ext cx="1603387" cy="164606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13D1DFC-FB2B-EED1-5D56-35FB8DA9EF69}"/>
                </a:ext>
              </a:extLst>
            </p:cNvPr>
            <p:cNvGrpSpPr/>
            <p:nvPr/>
          </p:nvGrpSpPr>
          <p:grpSpPr>
            <a:xfrm>
              <a:off x="3706587" y="2963905"/>
              <a:ext cx="3976081" cy="719332"/>
              <a:chOff x="4362051" y="2390560"/>
              <a:chExt cx="3994755" cy="1095776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81016649-2D7E-953C-C745-7FAD4E1742EA}"/>
                  </a:ext>
                </a:extLst>
              </p:cNvPr>
              <p:cNvGrpSpPr/>
              <p:nvPr/>
            </p:nvGrpSpPr>
            <p:grpSpPr>
              <a:xfrm>
                <a:off x="4362051" y="2390560"/>
                <a:ext cx="3930914" cy="0"/>
                <a:chOff x="5189365" y="4522981"/>
                <a:chExt cx="3930914" cy="0"/>
              </a:xfrm>
            </p:grpSpPr>
            <p:cxnSp>
              <p:nvCxnSpPr>
                <p:cNvPr id="11" name="Straight Connector 10">
                  <a:extLst>
                    <a:ext uri="{FF2B5EF4-FFF2-40B4-BE49-F238E27FC236}">
                      <a16:creationId xmlns:a16="http://schemas.microsoft.com/office/drawing/2014/main" id="{4D370927-9144-13F7-8E1E-9A6844B72D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89365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CECD102F-8A84-8D0A-3CE5-6C161E601B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64752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36AC4695-3201-7E60-B9EF-A683701AB2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38469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B5D477F8-EA0E-B282-1006-053821E5E9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260098" y="4522981"/>
                  <a:ext cx="86018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03157CB-BF45-4AC6-8325-1A3CE0E03C3D}"/>
                  </a:ext>
                </a:extLst>
              </p:cNvPr>
              <p:cNvSpPr txBox="1"/>
              <p:nvPr/>
            </p:nvSpPr>
            <p:spPr>
              <a:xfrm>
                <a:off x="4421969" y="2470673"/>
                <a:ext cx="3934837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-NO      BMI1-KO          WT-HO      BMI1-KO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	NO 		        HO</a:t>
                </a:r>
              </a:p>
              <a:p>
                <a:endParaRPr lang="en-US" dirty="0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C60AD81-5194-7219-DEED-38F9E8259B37}"/>
                </a:ext>
              </a:extLst>
            </p:cNvPr>
            <p:cNvSpPr txBox="1"/>
            <p:nvPr/>
          </p:nvSpPr>
          <p:spPr>
            <a:xfrm>
              <a:off x="10029239" y="2012770"/>
              <a:ext cx="87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K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966343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50DC0DD-F65E-40FD-A8A9-AC399324F652}"/>
              </a:ext>
            </a:extLst>
          </p:cNvPr>
          <p:cNvSpPr txBox="1"/>
          <p:nvPr/>
        </p:nvSpPr>
        <p:spPr>
          <a:xfrm>
            <a:off x="622457" y="212350"/>
            <a:ext cx="86887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WB for PTE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73E874E-8855-4B63-934E-56887DC1238D}"/>
              </a:ext>
            </a:extLst>
          </p:cNvPr>
          <p:cNvSpPr txBox="1"/>
          <p:nvPr/>
        </p:nvSpPr>
        <p:spPr>
          <a:xfrm>
            <a:off x="748938" y="4647540"/>
            <a:ext cx="9466216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te: 04-28-2020</a:t>
            </a:r>
          </a:p>
          <a:p>
            <a:r>
              <a:rPr lang="en-US" dirty="0"/>
              <a:t>Protein: 10ug WCL  12% gel, Transfer ON 30mV, </a:t>
            </a:r>
          </a:p>
          <a:p>
            <a:r>
              <a:rPr lang="en-US" dirty="0"/>
              <a:t>1st Antibody: PTEN anti Rabbit (ON 1:1000), CST #9188, 54 </a:t>
            </a:r>
            <a:r>
              <a:rPr lang="en-US" dirty="0" err="1"/>
              <a:t>kDa</a:t>
            </a:r>
            <a:r>
              <a:rPr lang="en-US" dirty="0"/>
              <a:t>   </a:t>
            </a:r>
          </a:p>
          <a:p>
            <a:r>
              <a:rPr lang="en-US" dirty="0"/>
              <a:t>2nd Antibody: GAR (1:5000)  </a:t>
            </a:r>
          </a:p>
          <a:p>
            <a:r>
              <a:rPr lang="en-US" dirty="0"/>
              <a:t>Developed 10sec ECL, KQ</a:t>
            </a:r>
          </a:p>
          <a:p>
            <a:r>
              <a:rPr lang="en-US" dirty="0"/>
              <a:t>NO: </a:t>
            </a:r>
            <a:r>
              <a:rPr lang="en-US" dirty="0" err="1"/>
              <a:t>normoxia</a:t>
            </a:r>
            <a:r>
              <a:rPr lang="en-US" dirty="0"/>
              <a:t>; HO: hyperoxia; WT: wild type; KO: Knockout</a:t>
            </a:r>
          </a:p>
          <a:p>
            <a:endParaRPr lang="en-US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7D77A5A0-E7AA-A6DC-CC98-AB581AC18664}"/>
              </a:ext>
            </a:extLst>
          </p:cNvPr>
          <p:cNvGrpSpPr/>
          <p:nvPr/>
        </p:nvGrpSpPr>
        <p:grpSpPr>
          <a:xfrm>
            <a:off x="3068373" y="816485"/>
            <a:ext cx="7146781" cy="3062496"/>
            <a:chOff x="3068373" y="816485"/>
            <a:chExt cx="7146781" cy="3062496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51AAD72-9A1E-8A08-7D3E-F77CA7201DB6}"/>
                </a:ext>
              </a:extLst>
            </p:cNvPr>
            <p:cNvGrpSpPr/>
            <p:nvPr/>
          </p:nvGrpSpPr>
          <p:grpSpPr>
            <a:xfrm>
              <a:off x="3068373" y="816485"/>
              <a:ext cx="5328459" cy="3062496"/>
              <a:chOff x="3982773" y="577203"/>
              <a:chExt cx="5328459" cy="3062496"/>
            </a:xfrm>
          </p:grpSpPr>
          <p:pic>
            <p:nvPicPr>
              <p:cNvPr id="23" name="Picture 22" descr="A close-up of a white background&#10;&#10;AI-generated content may be incorrect.">
                <a:extLst>
                  <a:ext uri="{FF2B5EF4-FFF2-40B4-BE49-F238E27FC236}">
                    <a16:creationId xmlns:a16="http://schemas.microsoft.com/office/drawing/2014/main" id="{493E38C1-EAB5-D88A-CA6C-EA80917BAD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61546" y="577203"/>
                <a:ext cx="5249686" cy="3062496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28B3DA3-DAAD-400A-B40A-CBEC14D67086}"/>
                  </a:ext>
                </a:extLst>
              </p:cNvPr>
              <p:cNvSpPr txBox="1"/>
              <p:nvPr/>
            </p:nvSpPr>
            <p:spPr>
              <a:xfrm>
                <a:off x="3982773" y="612460"/>
                <a:ext cx="685800" cy="2785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ts val="200"/>
                  </a:spcBef>
                </a:pPr>
                <a:r>
                  <a:rPr lang="en-US" sz="1000" dirty="0"/>
                  <a:t>250</a:t>
                </a:r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150</a:t>
                </a:r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100</a:t>
                </a:r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75</a:t>
                </a:r>
              </a:p>
              <a:p>
                <a:pPr>
                  <a:lnSpc>
                    <a:spcPct val="200000"/>
                  </a:lnSpc>
                  <a:spcBef>
                    <a:spcPts val="200"/>
                  </a:spcBef>
                </a:pPr>
                <a:r>
                  <a:rPr lang="en-US" sz="1000" dirty="0"/>
                  <a:t>50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37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lnSpc>
                    <a:spcPct val="150000"/>
                  </a:lnSpc>
                  <a:spcBef>
                    <a:spcPts val="200"/>
                  </a:spcBef>
                </a:pPr>
                <a:r>
                  <a:rPr lang="en-US" sz="1000" dirty="0"/>
                  <a:t>25</a:t>
                </a:r>
              </a:p>
              <a:p>
                <a:pPr>
                  <a:spcBef>
                    <a:spcPts val="200"/>
                  </a:spcBef>
                </a:pPr>
                <a:endParaRPr lang="en-US" sz="1000" dirty="0"/>
              </a:p>
              <a:p>
                <a:pPr>
                  <a:spcBef>
                    <a:spcPts val="200"/>
                  </a:spcBef>
                </a:pPr>
                <a:r>
                  <a:rPr lang="en-US" sz="1000" dirty="0"/>
                  <a:t>20</a:t>
                </a:r>
              </a:p>
              <a:p>
                <a:endParaRPr lang="en-US" sz="1000" dirty="0"/>
              </a:p>
              <a:p>
                <a:r>
                  <a:rPr lang="en-US" sz="1000" dirty="0"/>
                  <a:t>15</a:t>
                </a:r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69770B30-D6BE-0D06-B179-56C3C2149440}"/>
                  </a:ext>
                </a:extLst>
              </p:cNvPr>
              <p:cNvGrpSpPr/>
              <p:nvPr/>
            </p:nvGrpSpPr>
            <p:grpSpPr>
              <a:xfrm>
                <a:off x="4668573" y="1915381"/>
                <a:ext cx="4082321" cy="769441"/>
                <a:chOff x="4362051" y="2390560"/>
                <a:chExt cx="4082321" cy="769441"/>
              </a:xfrm>
            </p:grpSpPr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EA114FF6-F8E6-0FBF-C309-FF5321D5C625}"/>
                    </a:ext>
                  </a:extLst>
                </p:cNvPr>
                <p:cNvGrpSpPr/>
                <p:nvPr/>
              </p:nvGrpSpPr>
              <p:grpSpPr>
                <a:xfrm>
                  <a:off x="4362051" y="2390560"/>
                  <a:ext cx="3819816" cy="0"/>
                  <a:chOff x="5189365" y="4522981"/>
                  <a:chExt cx="3819816" cy="0"/>
                </a:xfrm>
              </p:grpSpPr>
              <p:cxnSp>
                <p:nvCxnSpPr>
                  <p:cNvPr id="18" name="Straight Connector 17">
                    <a:extLst>
                      <a:ext uri="{FF2B5EF4-FFF2-40B4-BE49-F238E27FC236}">
                        <a16:creationId xmlns:a16="http://schemas.microsoft.com/office/drawing/2014/main" id="{FD4CC586-0BCF-6D22-A2BA-949959C3B7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89365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18">
                    <a:extLst>
                      <a:ext uri="{FF2B5EF4-FFF2-40B4-BE49-F238E27FC236}">
                        <a16:creationId xmlns:a16="http://schemas.microsoft.com/office/drawing/2014/main" id="{29941ED3-E6BB-0041-1641-795DA88C23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64752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D30956E3-F79F-E28C-64F1-31950632DF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178647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Connector 20">
                    <a:extLst>
                      <a:ext uri="{FF2B5EF4-FFF2-40B4-BE49-F238E27FC236}">
                        <a16:creationId xmlns:a16="http://schemas.microsoft.com/office/drawing/2014/main" id="{64034D2D-BA6A-9357-D047-7CAE6113D7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149000" y="4522981"/>
                    <a:ext cx="86018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25E2482D-C2CB-66D7-1BD0-E56E73D2C348}"/>
                    </a:ext>
                  </a:extLst>
                </p:cNvPr>
                <p:cNvSpPr txBox="1"/>
                <p:nvPr/>
              </p:nvSpPr>
              <p:spPr>
                <a:xfrm>
                  <a:off x="4533064" y="2390560"/>
                  <a:ext cx="3911308" cy="7694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-NO      BMI1-KO          WT-HO      BMI1-KO</a:t>
                  </a:r>
                </a:p>
                <a:p>
                  <a:r>
                    <a:rPr lang="en-US" sz="1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NO 		        HO</a:t>
                  </a:r>
                </a:p>
                <a:p>
                  <a:endParaRPr lang="en-US" dirty="0"/>
                </a:p>
              </p:txBody>
            </p:sp>
          </p:grpSp>
        </p:grp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C73F524-563F-C73A-6274-A1C58BAFF5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73911" y="1805742"/>
              <a:ext cx="1603387" cy="164606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0FC24D1-6FD1-B479-594E-1CA5FFCE7A90}"/>
                </a:ext>
              </a:extLst>
            </p:cNvPr>
            <p:cNvSpPr txBox="1"/>
            <p:nvPr/>
          </p:nvSpPr>
          <p:spPr>
            <a:xfrm>
              <a:off x="9343483" y="1621076"/>
              <a:ext cx="87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TE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6978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9</TotalTime>
  <Words>830</Words>
  <Application>Microsoft Office PowerPoint</Application>
  <PresentationFormat>Widescreen</PresentationFormat>
  <Paragraphs>229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FIGURE 1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A</dc:title>
  <dc:creator>helena hernandez-cuervo</dc:creator>
  <cp:lastModifiedBy>Hernandez-Cuervo, Helena</cp:lastModifiedBy>
  <cp:revision>24</cp:revision>
  <dcterms:created xsi:type="dcterms:W3CDTF">2021-08-05T01:12:22Z</dcterms:created>
  <dcterms:modified xsi:type="dcterms:W3CDTF">2025-08-08T23:08:01Z</dcterms:modified>
</cp:coreProperties>
</file>